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6" clrIdx="0"/>
  <p:cmAuthor id="2" name="Susan" initials="SH" lastIdx="7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3" autoAdjust="0"/>
    <p:restoredTop sz="99451" autoAdjust="0"/>
  </p:normalViewPr>
  <p:slideViewPr>
    <p:cSldViewPr snapToGrid="0">
      <p:cViewPr varScale="1">
        <p:scale>
          <a:sx n="47" d="100"/>
          <a:sy n="47" d="100"/>
        </p:scale>
        <p:origin x="240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onaldt\Desktop\2019-XenoLuc%20publication%20(under%20review)\1st%20revision%20submission\B110%202D%20NHDF%20coculture%20day-4%20gfp%20analysi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onaldt\Desktop\2019-XenoLuc%20publication%20(under%20review)\1st%20revision%20submission\B110%203D%20spheroid%20NHDF%20coculture%20day-4%20gfp%20analysi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882401684829454"/>
          <c:y val="7.0059954116171219E-2"/>
          <c:w val="0.72911183698452375"/>
          <c:h val="0.69457587595544223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B110 2D NHDF coculture day-4 gfp analysis.XLS]Well summary'!$M$8:$M$10</c:f>
                <c:numCache>
                  <c:formatCode>General</c:formatCode>
                  <c:ptCount val="3"/>
                  <c:pt idx="0">
                    <c:v>25525375.41646577</c:v>
                  </c:pt>
                  <c:pt idx="1">
                    <c:v>53810274.370028928</c:v>
                  </c:pt>
                  <c:pt idx="2">
                    <c:v>35299297.010626771</c:v>
                  </c:pt>
                </c:numCache>
              </c:numRef>
            </c:plus>
            <c:minus>
              <c:numRef>
                <c:f>'[B110 2D NHDF coculture day-4 gfp analysis.XLS]Well summary'!$M$8:$M$10</c:f>
                <c:numCache>
                  <c:formatCode>General</c:formatCode>
                  <c:ptCount val="3"/>
                  <c:pt idx="0">
                    <c:v>25525375.41646577</c:v>
                  </c:pt>
                  <c:pt idx="1">
                    <c:v>53810274.370028928</c:v>
                  </c:pt>
                  <c:pt idx="2">
                    <c:v>35299297.0106267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B110 2D NHDF coculture day-4 gfp analysis.XLS]Well summary'!$K$8:$K$10</c:f>
              <c:strCache>
                <c:ptCount val="3"/>
                <c:pt idx="0">
                  <c:v>Monoculture</c:v>
                </c:pt>
                <c:pt idx="1">
                  <c:v>NHDFs</c:v>
                </c:pt>
                <c:pt idx="2">
                  <c:v>PBMCs</c:v>
                </c:pt>
              </c:strCache>
            </c:strRef>
          </c:cat>
          <c:val>
            <c:numRef>
              <c:f>'[B110 2D NHDF coculture day-4 gfp analysis.XLS]Well summary'!$L$8:$L$10</c:f>
              <c:numCache>
                <c:formatCode>General</c:formatCode>
                <c:ptCount val="3"/>
                <c:pt idx="0">
                  <c:v>317985833.33333331</c:v>
                </c:pt>
                <c:pt idx="1">
                  <c:v>501435555.55555558</c:v>
                </c:pt>
                <c:pt idx="2">
                  <c:v>407547777.77777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30-4CBD-9A47-D5A07AD450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9221144"/>
        <c:axId val="1"/>
      </c:barChart>
      <c:catAx>
        <c:axId val="359221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0.0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592211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186074270407828"/>
          <c:y val="5.2308691095591851E-2"/>
          <c:w val="0.73338427719158905"/>
          <c:h val="0.82966231694536419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B110 3D spheroid NHDF coculture day-4 gfp analysis.xls]page 1'!$L$7:$L$9</c:f>
                <c:numCache>
                  <c:formatCode>General</c:formatCode>
                  <c:ptCount val="3"/>
                  <c:pt idx="0">
                    <c:v>25043375.427002203</c:v>
                  </c:pt>
                  <c:pt idx="1">
                    <c:v>76654861.391825631</c:v>
                  </c:pt>
                  <c:pt idx="2">
                    <c:v>55610133.543966413</c:v>
                  </c:pt>
                </c:numCache>
              </c:numRef>
            </c:plus>
            <c:minus>
              <c:numRef>
                <c:f>'[B110 3D spheroid NHDF coculture day-4 gfp analysis.xls]page 1'!$L$7:$L$9</c:f>
                <c:numCache>
                  <c:formatCode>General</c:formatCode>
                  <c:ptCount val="3"/>
                  <c:pt idx="0">
                    <c:v>25043375.427002203</c:v>
                  </c:pt>
                  <c:pt idx="1">
                    <c:v>76654861.391825631</c:v>
                  </c:pt>
                  <c:pt idx="2">
                    <c:v>55610133.5439664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B110 3D spheroid NHDF coculture day-4 gfp analysis.xls]page 1'!$J$7:$J$9</c:f>
              <c:strCache>
                <c:ptCount val="3"/>
                <c:pt idx="0">
                  <c:v>Monoculture</c:v>
                </c:pt>
                <c:pt idx="1">
                  <c:v>NHDFs</c:v>
                </c:pt>
                <c:pt idx="2">
                  <c:v>PBMCs</c:v>
                </c:pt>
              </c:strCache>
            </c:strRef>
          </c:cat>
          <c:val>
            <c:numRef>
              <c:f>'[B110 3D spheroid NHDF coculture day-4 gfp analysis.xls]page 1'!$K$7:$K$9</c:f>
              <c:numCache>
                <c:formatCode>General</c:formatCode>
                <c:ptCount val="3"/>
                <c:pt idx="0">
                  <c:v>555154444.44444442</c:v>
                </c:pt>
                <c:pt idx="1">
                  <c:v>735243333.33333337</c:v>
                </c:pt>
                <c:pt idx="2">
                  <c:v>598484444.444444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8C-47CF-9641-696EF9DCA6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4486448"/>
        <c:axId val="1"/>
      </c:barChart>
      <c:catAx>
        <c:axId val="354486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0.00E+0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544864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DCF59D-A455-4455-9255-F234A60AEA7F}" type="datetimeFigureOut">
              <a:rPr lang="en-MY" smtClean="0"/>
              <a:t>15/4/2019</a:t>
            </a:fld>
            <a:endParaRPr lang="en-M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M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6F327B-117E-4541-90F5-D88BEF3E3B97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38694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6F327B-117E-4541-90F5-D88BEF3E3B97}" type="slidenum">
              <a:rPr lang="en-MY" smtClean="0"/>
              <a:t>1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87688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0F021-1274-47D2-AFB4-0EE6EC0B1E33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72A7-9A5D-4E98-845A-D0069E1C6B40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C581F-F929-44D6-A4CE-8F76130C8A54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98D11-9C37-461D-B76B-EFCBB1704881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79D7-8623-4FAA-AC6D-0C7555325C6A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C212A-426F-4445-BFB7-8BD5D91CDD04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A0040-B0A6-418F-8278-AEDD500E1F0D}" type="datetime1">
              <a:rPr lang="en-US" smtClean="0"/>
              <a:t>4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6D794-079F-4B44-A7C3-68E3BA215814}" type="datetime1">
              <a:rPr lang="en-US" smtClean="0"/>
              <a:t>4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6ABCD-F7FF-47DE-A90E-574F763FE900}" type="datetime1">
              <a:rPr lang="en-US" smtClean="0"/>
              <a:t>4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B0F0F-09D8-408F-B710-8B995EEBC957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643E9-AB3F-4C16-8F61-3D81199BDB44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BCF2E-4AE9-41F0-A139-1AF658B2506B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2268544" y="5509377"/>
            <a:ext cx="266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834605" y="5576639"/>
            <a:ext cx="19068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400" dirty="0" smtClean="0"/>
              <a:t>Co-culture partner</a:t>
            </a:r>
            <a:endParaRPr lang="en-MY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991063" y="1682361"/>
            <a:ext cx="400110" cy="27178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MY" sz="1400" b="1" dirty="0"/>
              <a:t>Relative </a:t>
            </a:r>
            <a:r>
              <a:rPr lang="en-MY" sz="1400" b="1" dirty="0" smtClean="0"/>
              <a:t>fluorescence unit </a:t>
            </a:r>
            <a:r>
              <a:rPr lang="en-MY" sz="1400" b="1" dirty="0"/>
              <a:t>(</a:t>
            </a:r>
            <a:r>
              <a:rPr lang="en-MY" sz="1400" b="1" dirty="0" smtClean="0"/>
              <a:t>RFU) </a:t>
            </a:r>
            <a:endParaRPr lang="en-MY" sz="1400" b="1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5306682" y="1549783"/>
            <a:ext cx="0" cy="1143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306622" y="1492632"/>
            <a:ext cx="400110" cy="337781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MY" sz="1400" b="1" dirty="0"/>
              <a:t>      2D model                       </a:t>
            </a:r>
            <a:r>
              <a:rPr lang="en-MY" sz="1400" b="1" dirty="0" smtClean="0"/>
              <a:t>           </a:t>
            </a:r>
            <a:r>
              <a:rPr lang="en-MY" sz="1400" b="1" dirty="0"/>
              <a:t>3D model                                          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1382280" y="1772253"/>
            <a:ext cx="0" cy="2819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511091" y="1184856"/>
            <a:ext cx="38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  <a:endParaRPr lang="en-MY" sz="14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1502198" y="3334482"/>
            <a:ext cx="405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  <a:endParaRPr lang="en-MY" sz="1400" b="1" dirty="0"/>
          </a:p>
        </p:txBody>
      </p:sp>
      <p:cxnSp>
        <p:nvCxnSpPr>
          <p:cNvPr id="39" name="Straight Connector 38"/>
          <p:cNvCxnSpPr/>
          <p:nvPr/>
        </p:nvCxnSpPr>
        <p:spPr>
          <a:xfrm>
            <a:off x="5306622" y="3617716"/>
            <a:ext cx="0" cy="1143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250458"/>
              </p:ext>
            </p:extLst>
          </p:nvPr>
        </p:nvGraphicFramePr>
        <p:xfrm>
          <a:off x="1782390" y="1184856"/>
          <a:ext cx="3403782" cy="22421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0078546"/>
              </p:ext>
            </p:extLst>
          </p:nvPr>
        </p:nvGraphicFramePr>
        <p:xfrm>
          <a:off x="1773498" y="3334483"/>
          <a:ext cx="3412674" cy="19129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9</TotalTime>
  <Words>16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Dr. Ronald Teow Sin Yeang</cp:lastModifiedBy>
  <cp:revision>658</cp:revision>
  <dcterms:created xsi:type="dcterms:W3CDTF">2006-08-16T00:00:00Z</dcterms:created>
  <dcterms:modified xsi:type="dcterms:W3CDTF">2019-04-15T09:45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7439</vt:lpwstr>
  </property>
</Properties>
</file>